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1" r:id="rId3"/>
    <p:sldId id="260" r:id="rId4"/>
    <p:sldId id="259" r:id="rId5"/>
  </p:sldIdLst>
  <p:sldSz cx="6858000" cy="9144000" type="screen4x3"/>
  <p:notesSz cx="7099300" cy="1023461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201" autoAdjust="0"/>
  </p:normalViewPr>
  <p:slideViewPr>
    <p:cSldViewPr showGuides="1">
      <p:cViewPr varScale="1">
        <p:scale>
          <a:sx n="88" d="100"/>
          <a:sy n="88" d="100"/>
        </p:scale>
        <p:origin x="-3804" y="-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F362B-7C93-4721-9C5E-0DC5D48BBC50}" type="datetimeFigureOut">
              <a:rPr lang="de-DE" smtClean="0"/>
              <a:t>23.05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A0EFE-8BCD-4BAA-9BCF-094EAA048E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873571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F362B-7C93-4721-9C5E-0DC5D48BBC50}" type="datetimeFigureOut">
              <a:rPr lang="de-DE" smtClean="0"/>
              <a:t>23.05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A0EFE-8BCD-4BAA-9BCF-094EAA048E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659742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F362B-7C93-4721-9C5E-0DC5D48BBC50}" type="datetimeFigureOut">
              <a:rPr lang="de-DE" smtClean="0"/>
              <a:t>23.05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A0EFE-8BCD-4BAA-9BCF-094EAA048E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30535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F362B-7C93-4721-9C5E-0DC5D48BBC50}" type="datetimeFigureOut">
              <a:rPr lang="de-DE" smtClean="0"/>
              <a:t>23.05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A0EFE-8BCD-4BAA-9BCF-094EAA048E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885435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F362B-7C93-4721-9C5E-0DC5D48BBC50}" type="datetimeFigureOut">
              <a:rPr lang="de-DE" smtClean="0"/>
              <a:t>23.05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A0EFE-8BCD-4BAA-9BCF-094EAA048E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759502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F362B-7C93-4721-9C5E-0DC5D48BBC50}" type="datetimeFigureOut">
              <a:rPr lang="de-DE" smtClean="0"/>
              <a:t>23.05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A0EFE-8BCD-4BAA-9BCF-094EAA048E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840529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F362B-7C93-4721-9C5E-0DC5D48BBC50}" type="datetimeFigureOut">
              <a:rPr lang="de-DE" smtClean="0"/>
              <a:t>23.05.2019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A0EFE-8BCD-4BAA-9BCF-094EAA048E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211227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F362B-7C93-4721-9C5E-0DC5D48BBC50}" type="datetimeFigureOut">
              <a:rPr lang="de-DE" smtClean="0"/>
              <a:t>23.05.2019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A0EFE-8BCD-4BAA-9BCF-094EAA048E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939000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F362B-7C93-4721-9C5E-0DC5D48BBC50}" type="datetimeFigureOut">
              <a:rPr lang="de-DE" smtClean="0"/>
              <a:t>23.05.2019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A0EFE-8BCD-4BAA-9BCF-094EAA048E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739702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F362B-7C93-4721-9C5E-0DC5D48BBC50}" type="datetimeFigureOut">
              <a:rPr lang="de-DE" smtClean="0"/>
              <a:t>23.05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A0EFE-8BCD-4BAA-9BCF-094EAA048E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369712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F362B-7C93-4721-9C5E-0DC5D48BBC50}" type="datetimeFigureOut">
              <a:rPr lang="de-DE" smtClean="0"/>
              <a:t>23.05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A0EFE-8BCD-4BAA-9BCF-094EAA048E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123190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6F362B-7C93-4721-9C5E-0DC5D48BBC50}" type="datetimeFigureOut">
              <a:rPr lang="de-DE" smtClean="0"/>
              <a:t>23.05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5A0EFE-8BCD-4BAA-9BCF-094EAA048E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206438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-15954" y="3344"/>
            <a:ext cx="23145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E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ure 1</a:t>
            </a:r>
            <a:endParaRPr lang="de-DE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48364" y="31262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A</a:t>
            </a:r>
            <a:endParaRPr lang="de-DE" dirty="0"/>
          </a:p>
        </p:txBody>
      </p:sp>
      <p:sp>
        <p:nvSpPr>
          <p:cNvPr id="6" name="TextBox 5"/>
          <p:cNvSpPr txBox="1"/>
          <p:nvPr/>
        </p:nvSpPr>
        <p:spPr>
          <a:xfrm>
            <a:off x="48364" y="268789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B</a:t>
            </a:r>
            <a:endParaRPr lang="de-DE" dirty="0"/>
          </a:p>
        </p:txBody>
      </p:sp>
      <p:sp>
        <p:nvSpPr>
          <p:cNvPr id="10" name="Rectangle 9"/>
          <p:cNvSpPr/>
          <p:nvPr/>
        </p:nvSpPr>
        <p:spPr>
          <a:xfrm>
            <a:off x="404664" y="1567301"/>
            <a:ext cx="983572" cy="116998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2" name="Rectangle 11"/>
          <p:cNvSpPr/>
          <p:nvPr/>
        </p:nvSpPr>
        <p:spPr>
          <a:xfrm>
            <a:off x="457380" y="4040326"/>
            <a:ext cx="1071563" cy="116998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pic>
        <p:nvPicPr>
          <p:cNvPr id="32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9305"/>
          <a:stretch/>
        </p:blipFill>
        <p:spPr bwMode="auto">
          <a:xfrm>
            <a:off x="493271" y="2687894"/>
            <a:ext cx="4273401" cy="25224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7" name="Rectangle 36"/>
          <p:cNvSpPr/>
          <p:nvPr/>
        </p:nvSpPr>
        <p:spPr>
          <a:xfrm>
            <a:off x="93460" y="8115632"/>
            <a:ext cx="6726114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: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ating strategy for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hM</a:t>
            </a:r>
            <a:r>
              <a:rPr lang="el-G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φ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s derive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ver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peripheral blood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pectively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s were defined as single, CD45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HLA-DR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D3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CD19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CD56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zombie Aqua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and then CD14/CD16 markers defined classical/non-classical/intermediate MOs subset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 and D)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-SNE analyses of two additional sample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owing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of CD49a, CD83, CD86, CD80, CD69, CD32 and CD11c. 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4664" y="391796"/>
            <a:ext cx="4273401" cy="24357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843236" y="297240"/>
            <a:ext cx="52770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 err="1" smtClean="0"/>
              <a:t>leukocytes</a:t>
            </a:r>
            <a:endParaRPr lang="en-US" sz="6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1844824" y="312629"/>
            <a:ext cx="53412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 smtClean="0"/>
              <a:t>single </a:t>
            </a:r>
            <a:r>
              <a:rPr lang="es-ES" sz="600" b="1" dirty="0" err="1" smtClean="0"/>
              <a:t>cells</a:t>
            </a:r>
            <a:endParaRPr lang="en-US" sz="6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2894879" y="312629"/>
            <a:ext cx="53412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 smtClean="0"/>
              <a:t>single </a:t>
            </a:r>
            <a:r>
              <a:rPr lang="es-ES" sz="600" b="1" dirty="0" err="1" smtClean="0"/>
              <a:t>cells</a:t>
            </a:r>
            <a:endParaRPr lang="en-US" sz="6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4001234" y="312629"/>
            <a:ext cx="3882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 smtClean="0"/>
              <a:t>CD45+</a:t>
            </a:r>
            <a:endParaRPr lang="en-US" sz="6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3999694" y="1671171"/>
            <a:ext cx="46519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 smtClean="0"/>
              <a:t>HLA-DR+</a:t>
            </a:r>
            <a:endParaRPr lang="en-US" sz="6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2848173" y="1671171"/>
            <a:ext cx="78579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 smtClean="0"/>
              <a:t>CD3</a:t>
            </a:r>
            <a:r>
              <a:rPr lang="es-ES" sz="600" b="1" baseline="30000" dirty="0"/>
              <a:t>-</a:t>
            </a:r>
            <a:r>
              <a:rPr lang="es-ES" sz="600" b="1" dirty="0" smtClean="0"/>
              <a:t>CD19</a:t>
            </a:r>
            <a:r>
              <a:rPr lang="es-ES" sz="600" b="1" baseline="30000" dirty="0"/>
              <a:t>-</a:t>
            </a:r>
            <a:r>
              <a:rPr lang="es-ES" sz="600" b="1" dirty="0" smtClean="0"/>
              <a:t>CD56</a:t>
            </a:r>
            <a:r>
              <a:rPr lang="es-ES" sz="600" b="1" baseline="30000" dirty="0"/>
              <a:t>-</a:t>
            </a:r>
            <a:r>
              <a:rPr lang="es-ES" sz="600" b="1" dirty="0" smtClean="0"/>
              <a:t>LD</a:t>
            </a:r>
            <a:r>
              <a:rPr lang="es-ES" sz="600" b="1" baseline="30000" dirty="0" smtClean="0"/>
              <a:t>-</a:t>
            </a:r>
            <a:endParaRPr lang="en-US" sz="600" b="1" baseline="30000" dirty="0"/>
          </a:p>
        </p:txBody>
      </p:sp>
      <p:sp>
        <p:nvSpPr>
          <p:cNvPr id="17" name="TextBox 16"/>
          <p:cNvSpPr txBox="1"/>
          <p:nvPr/>
        </p:nvSpPr>
        <p:spPr>
          <a:xfrm>
            <a:off x="1879902" y="1671171"/>
            <a:ext cx="50687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 err="1" smtClean="0"/>
              <a:t>MOs</a:t>
            </a:r>
            <a:r>
              <a:rPr lang="es-ES" sz="600" b="1" dirty="0" smtClean="0"/>
              <a:t>/M</a:t>
            </a:r>
            <a:r>
              <a:rPr lang="el-GR" sz="600" b="1" dirty="0" smtClean="0"/>
              <a:t>ϕ</a:t>
            </a:r>
            <a:r>
              <a:rPr lang="es-ES" sz="600" b="1" dirty="0" smtClean="0"/>
              <a:t> </a:t>
            </a:r>
            <a:endParaRPr lang="en-US" sz="600" b="1" baseline="30000" dirty="0"/>
          </a:p>
        </p:txBody>
      </p:sp>
      <p:sp>
        <p:nvSpPr>
          <p:cNvPr id="18" name="TextBox 17"/>
          <p:cNvSpPr txBox="1"/>
          <p:nvPr/>
        </p:nvSpPr>
        <p:spPr>
          <a:xfrm>
            <a:off x="723175" y="1671171"/>
            <a:ext cx="7473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 err="1"/>
              <a:t>MOs</a:t>
            </a:r>
            <a:r>
              <a:rPr lang="es-ES" sz="600" b="1" dirty="0"/>
              <a:t>/M</a:t>
            </a:r>
            <a:r>
              <a:rPr lang="el-GR" sz="600" b="1" dirty="0"/>
              <a:t>ϕ</a:t>
            </a:r>
            <a:r>
              <a:rPr lang="es-ES" sz="600" b="1" dirty="0"/>
              <a:t> </a:t>
            </a:r>
            <a:r>
              <a:rPr lang="en-US" sz="600" b="1" dirty="0" smtClean="0"/>
              <a:t>subsets</a:t>
            </a:r>
            <a:endParaRPr lang="en-US" sz="600" b="1" baseline="30000" dirty="0"/>
          </a:p>
        </p:txBody>
      </p:sp>
      <p:cxnSp>
        <p:nvCxnSpPr>
          <p:cNvPr id="7" name="Straight Arrow Connector 6"/>
          <p:cNvCxnSpPr/>
          <p:nvPr/>
        </p:nvCxnSpPr>
        <p:spPr>
          <a:xfrm>
            <a:off x="1268760" y="1023099"/>
            <a:ext cx="360040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/>
          <p:cNvCxnSpPr/>
          <p:nvPr/>
        </p:nvCxnSpPr>
        <p:spPr>
          <a:xfrm>
            <a:off x="2298590" y="1022003"/>
            <a:ext cx="360040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/>
          <p:cNvCxnSpPr/>
          <p:nvPr/>
        </p:nvCxnSpPr>
        <p:spPr>
          <a:xfrm>
            <a:off x="3248980" y="1013287"/>
            <a:ext cx="384986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/>
          <p:cNvCxnSpPr/>
          <p:nvPr/>
        </p:nvCxnSpPr>
        <p:spPr>
          <a:xfrm>
            <a:off x="4509120" y="1177620"/>
            <a:ext cx="0" cy="432048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/>
          <p:nvPr/>
        </p:nvCxnSpPr>
        <p:spPr>
          <a:xfrm flipH="1">
            <a:off x="3573016" y="2570674"/>
            <a:ext cx="597562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/>
          <p:cNvCxnSpPr/>
          <p:nvPr/>
        </p:nvCxnSpPr>
        <p:spPr>
          <a:xfrm flipH="1">
            <a:off x="2478610" y="2535267"/>
            <a:ext cx="467258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/>
          <p:cNvCxnSpPr/>
          <p:nvPr/>
        </p:nvCxnSpPr>
        <p:spPr>
          <a:xfrm flipH="1">
            <a:off x="1470495" y="2031211"/>
            <a:ext cx="325733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6173" y="5602972"/>
            <a:ext cx="6327163" cy="25157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6" name="TextBox 25"/>
          <p:cNvSpPr txBox="1"/>
          <p:nvPr/>
        </p:nvSpPr>
        <p:spPr>
          <a:xfrm>
            <a:off x="14940" y="535534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C</a:t>
            </a:r>
            <a:endParaRPr lang="de-DE" dirty="0"/>
          </a:p>
        </p:txBody>
      </p:sp>
      <p:sp>
        <p:nvSpPr>
          <p:cNvPr id="28" name="TextBox 27"/>
          <p:cNvSpPr txBox="1"/>
          <p:nvPr/>
        </p:nvSpPr>
        <p:spPr>
          <a:xfrm>
            <a:off x="3316250" y="5362236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D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0407444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12"/>
          <p:cNvSpPr/>
          <p:nvPr/>
        </p:nvSpPr>
        <p:spPr>
          <a:xfrm>
            <a:off x="-15220" y="5292080"/>
            <a:ext cx="6418159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: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ative flow cytometry plot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SIG4, CD49a 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RCO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aining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red) and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ir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rresponding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otype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s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ted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hM</a:t>
            </a:r>
            <a:r>
              <a:rPr lang="el-G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ϕ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(B)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alidation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ining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MARCO in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nstimulated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BMCs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ft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and 48h-IL-10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imulated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BMCs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ight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ted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nocytes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-4544" y="-2222"/>
            <a:ext cx="23145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E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ure 2</a:t>
            </a:r>
            <a:endParaRPr lang="de-DE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150" y="755576"/>
            <a:ext cx="5914154" cy="21623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953" y="3131840"/>
            <a:ext cx="4206355" cy="19442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8" name="TextBox 27"/>
          <p:cNvSpPr txBox="1"/>
          <p:nvPr/>
        </p:nvSpPr>
        <p:spPr>
          <a:xfrm>
            <a:off x="0" y="32352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A</a:t>
            </a:r>
            <a:endParaRPr lang="de-DE" b="1" dirty="0"/>
          </a:p>
        </p:txBody>
      </p:sp>
      <p:sp>
        <p:nvSpPr>
          <p:cNvPr id="29" name="TextBox 28"/>
          <p:cNvSpPr txBox="1"/>
          <p:nvPr/>
        </p:nvSpPr>
        <p:spPr>
          <a:xfrm>
            <a:off x="0" y="280780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B</a:t>
            </a:r>
            <a:endParaRPr lang="de-DE" b="1" dirty="0"/>
          </a:p>
        </p:txBody>
      </p:sp>
    </p:spTree>
    <p:extLst>
      <p:ext uri="{BB962C8B-B14F-4D97-AF65-F5344CB8AC3E}">
        <p14:creationId xmlns:p14="http://schemas.microsoft.com/office/powerpoint/2010/main" val="39984358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-734" y="9208"/>
            <a:ext cx="23145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E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ure 3</a:t>
            </a:r>
            <a:endParaRPr lang="de-DE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0" y="32352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de-DE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0" y="2274103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de-DE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075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942" r="14413"/>
          <a:stretch/>
        </p:blipFill>
        <p:spPr bwMode="auto">
          <a:xfrm>
            <a:off x="406876" y="2878685"/>
            <a:ext cx="6190476" cy="276997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Rectangle 14"/>
          <p:cNvSpPr/>
          <p:nvPr/>
        </p:nvSpPr>
        <p:spPr>
          <a:xfrm>
            <a:off x="-734" y="7974449"/>
            <a:ext cx="6858000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ative Controls of liver tissue auto fluorescence for all 4 channels and merge (right)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mmunofluorescenc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ining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Hoechst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68,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SIG4 and CD49a at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10 (top) and x40 (lower pictures) magnification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ining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human healthy donor tissue slides (12µm thick) for CD68 (blue) and CD49 (green);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x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gnification (left) an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0x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gnification (right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endParaRPr lang="es-ES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6912" y="6353083"/>
            <a:ext cx="3398504" cy="15653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3487" y="666622"/>
            <a:ext cx="3212066" cy="16011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7" name="TextBox 16"/>
          <p:cNvSpPr txBox="1"/>
          <p:nvPr/>
        </p:nvSpPr>
        <p:spPr>
          <a:xfrm>
            <a:off x="0" y="586814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de-DE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555631" y="2619270"/>
            <a:ext cx="68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oescht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847036" y="2637454"/>
            <a:ext cx="5517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68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215016" y="2637454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SIG4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367416" y="2789854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SIG4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4367316" y="2620180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49a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5591452" y="2620180"/>
            <a:ext cx="568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rge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84936" y="3223187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10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84936" y="4132869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40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84936" y="4982941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40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646347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/>
          <p:cNvSpPr txBox="1"/>
          <p:nvPr/>
        </p:nvSpPr>
        <p:spPr>
          <a:xfrm>
            <a:off x="-20538" y="0"/>
            <a:ext cx="23145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E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ure 4</a:t>
            </a:r>
            <a:endParaRPr lang="de-DE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6886" y="3491880"/>
            <a:ext cx="6726114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: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catter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ots showing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calculated intensity on stained tissue slides of CD49a on CD49a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/-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ignals (left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=291 for CD49a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=270 for CD49a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VSIG4 on VSIG4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/-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ignals (middle) (n=209 for VSIG4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n=352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VSIG4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and MARCO on  MARCO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/-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ignal (left) (n=247 for MARCO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n=314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MARCO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).</a:t>
            </a:r>
            <a:endParaRPr lang="es-ES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78" y="683568"/>
            <a:ext cx="6737301" cy="2090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9117112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34</Words>
  <Application>Microsoft Office PowerPoint</Application>
  <PresentationFormat>On-screen Show (4:3)</PresentationFormat>
  <Paragraphs>34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Heinrich-Pette-Institu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trus, Gloria</dc:creator>
  <cp:lastModifiedBy>Martrus, Gloria</cp:lastModifiedBy>
  <cp:revision>47</cp:revision>
  <cp:lastPrinted>2019-03-29T14:47:50Z</cp:lastPrinted>
  <dcterms:created xsi:type="dcterms:W3CDTF">2018-09-25T10:43:42Z</dcterms:created>
  <dcterms:modified xsi:type="dcterms:W3CDTF">2019-05-23T10:42:10Z</dcterms:modified>
</cp:coreProperties>
</file>